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4424BB75-1FE0-44F3-BD3D-9ED0B59CB745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E8508830-1D3F-4F7D-B35E-2494865213A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660821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Google Shape;118;g34fe5d1bc1b_0_4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9" name="Google Shape;119;g34fe5d1bc1b_0_4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C73539-38B9-42AB-AB0A-838C9EC824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4E1002-C41C-4B11-930D-06C80122C1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071D65-A3BF-4F67-B895-7AEEECBCA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769DE0-169C-4928-B073-2B0788D5C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DE9EB5-C9B6-4092-929C-18A13BD0F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55312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E1CC5A-2074-41E4-B0FB-D78EE68FEF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9CE893-A2A2-471F-AA42-8520C092D6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922FA9-FA02-4FBA-97CC-30C7B5FF4A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C49403-2457-435B-B51C-FCA7205541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30D6D9-A881-4812-BD10-FDE5D42C0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7587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620F7B-3816-4355-9246-0D70078F48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3EA078-79BF-4FC0-88A6-5B0C4AB82F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8D6498-9BD4-413A-B5B0-C25F72FD1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21D38-5714-4F09-82A6-DE8D7E0CA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8737DC-C2E5-49B1-A935-80308C5633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0475259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609585" lvl="0" indent="-457189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1219170" lvl="1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828754" lvl="2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2438339" lvl="3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3047924" lvl="4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3657509" lvl="5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4267093" lvl="6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4876678" lvl="7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5486263" lvl="8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algn="r"/>
            <a:fld id="{00000000-1234-1234-1234-123412341234}" type="slidenum">
              <a:rPr lang="en" smtClean="0"/>
              <a:pPr algn="r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409606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042916-FBC2-47E2-A23F-EB370FA5D4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E64F06-8CF1-4BF1-86CE-C393FFCAF4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363E34-9FC4-4E3A-BA26-93B74FA70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116C1C-DBF0-44C0-90D5-EAFBF1C38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32AC57-59DE-4633-A478-FEFF78B33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66975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85BBD-1903-4B90-A56B-2B2B3F07C2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38A9A0-8961-4FBA-B404-033A8345FE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02B91-33BA-4873-98CD-98CAA157E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4783B3-29E8-4EEF-A82E-113A577C2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86F1E-AB21-44B4-9B91-564EA023C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63779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3FDA3-2276-41BC-95DB-232CA703F8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93D5D0-0C56-4CCA-8F94-AB6BE47E2D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40632E-4E21-40C2-B009-9B4A6D7770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B49667-9659-479B-82CE-FD2480F55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D4909E-7D56-4924-900E-0F54A8B94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4C73B3-5832-4616-A649-D8720777F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48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1FA57A-27F3-48EB-BCA8-3F10AB2A84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FC7781-80BD-47E1-ABB1-C550850419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D0836C-0267-4BDC-8AB0-26C1536DD7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426BA91-22FE-4246-8210-8ED296586E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CDD9DA-BFBF-48B3-8900-5C88E0A9DF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4B1CB7B-AEC5-4BB3-A54C-3280E67F3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8AD07A6-F18F-4A03-8EDC-E2F6E1E5C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4D1A232-2AD8-43E0-BC96-6FBB62F59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33576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C2438-4E69-4AA2-B5C5-11EBF485EC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DF478D-DFFB-4FE5-A48C-675312776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4B6A9E0-E679-41FE-A234-621875804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E040C3-AE50-4564-8EAA-FCBC61F57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94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EECA66-E91B-4EE5-916E-C738AE2BE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C07E49A-3BD2-441B-8D13-A745BB359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4A8CEE-BCD1-4830-A341-81D486520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23336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660020-BA06-4546-8D65-4AFF93944D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10FEDB-E994-422E-8797-478B18D036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0F216B-ECCA-436A-A605-5D1498A1F7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9A8265-F17F-4E54-8D02-FC08B9498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B498B0-57AE-4EA6-A086-1577619B4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6F7987-07FB-4C95-A001-A34DA8E52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7668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2CFD02-7166-44AA-96FA-86C9F15DB5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1AFE89-FB73-46B5-800A-5503F258DA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AE9843-AA35-405C-90DB-DBD2D1348C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463171-6D38-4A6F-9579-C91940086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D5C1E7-19A7-4737-9022-8E19B6410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9E6FFA-1882-40F5-98EF-F5099C803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68276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835F9F-2F9C-4BE0-9F0C-5CF47A5E35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F04619-4949-4EBC-9B91-902E4714A2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DFA565-DB78-49C1-BDF1-A98795A7C6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F4CEB0-5E4B-487A-9AE0-F89E81F4F323}" type="datetimeFigureOut">
              <a:rPr lang="he-IL" smtClean="0"/>
              <a:t>כ"ט/שבט/תשפ"ו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357411-4B6A-40D5-A752-009273ACC5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C088D5-D09A-4E73-AF13-4FD9A9335F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232746-E9F8-4979-B33A-8CAA5D6718B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67950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18"/>
          <p:cNvSpPr txBox="1"/>
          <p:nvPr/>
        </p:nvSpPr>
        <p:spPr>
          <a:xfrm>
            <a:off x="387167" y="5225933"/>
            <a:ext cx="11231200" cy="13541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spAutoFit/>
          </a:bodyPr>
          <a:lstStyle/>
          <a:p>
            <a:r>
              <a:rPr lang="en-US" sz="12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igure S1. 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chematic representation of the gene constructs used for genetic transformation of cassava: (A) RNAi constructs </a:t>
            </a:r>
            <a:r>
              <a:rPr lang="en-US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nd</a:t>
            </a:r>
            <a:r>
              <a:rPr lang="e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(</a:t>
            </a:r>
            <a:r>
              <a:rPr lang="en-US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) 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tSUC2: GUS T-DNA. RB and LB symbolizes the right and left borders of the T-DNA respectively, AtSUC2: Sucrose transporter promoter from 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rabidopsis thaliana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PDK intron: </a:t>
            </a:r>
            <a:r>
              <a:rPr lang="en" sz="1200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Pyruvate orthophosphate dikinase from </a:t>
            </a:r>
            <a:r>
              <a:rPr lang="en" sz="1200" i="1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Fla</a:t>
            </a:r>
            <a:r>
              <a:rPr lang="en" sz="1200" b="1" i="1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v</a:t>
            </a:r>
            <a:r>
              <a:rPr lang="en" sz="1200" i="1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eria trinervia</a:t>
            </a:r>
            <a:r>
              <a:rPr lang="en" sz="1200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, sense and antisense genes- RNAi genes (Table </a:t>
            </a:r>
            <a:r>
              <a:rPr lang="en-US" sz="1200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S1</a:t>
            </a:r>
            <a:r>
              <a:rPr lang="en" sz="1200" dirty="0">
                <a:solidFill>
                  <a:schemeClr val="dk1"/>
                </a:solidFill>
                <a:highlight>
                  <a:srgbClr val="FFFFFF"/>
                </a:highlight>
                <a:latin typeface="Times New Roman"/>
                <a:ea typeface="Times New Roman"/>
                <a:cs typeface="Times New Roman"/>
                <a:sym typeface="Times New Roman"/>
              </a:rPr>
              <a:t>), OCS Term: Octopine synthase terminator from 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grobacterium tumefaciens, </a:t>
            </a:r>
            <a:r>
              <a:rPr lang="en-US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2X </a:t>
            </a:r>
            <a:r>
              <a:rPr lang="en-US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MV</a:t>
            </a:r>
            <a:r>
              <a:rPr lang="en-US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35S prom: Cauliflower mosaic virus (</a:t>
            </a:r>
            <a:r>
              <a:rPr lang="en-US" sz="1200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aMV</a:t>
            </a:r>
            <a:r>
              <a:rPr lang="en-US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 35S promoter, 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NPTII: Neomycin phospho transferase from 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scherichia coli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</a:t>
            </a:r>
            <a:r>
              <a:rPr lang="en-US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HPTII: hygromycin phospho transferase from 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scherichia coli, 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NOS Term: 3’ nopaline synthase UTR from 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grobacterium tumefaciens, 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US: 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β-glucuronidase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from 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scherichia coli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lang="en" sz="12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NOS prom: Nopaline synthase promoter from </a:t>
            </a:r>
            <a:r>
              <a:rPr lang="en" sz="1200" i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grobacterium tumefaciens.</a:t>
            </a:r>
            <a:endParaRPr sz="1200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pic>
        <p:nvPicPr>
          <p:cNvPr id="122" name="Google Shape;122;p18"/>
          <p:cNvPicPr preferRelativeResize="0"/>
          <p:nvPr/>
        </p:nvPicPr>
        <p:blipFill rotWithShape="1">
          <a:blip r:embed="rId3">
            <a:alphaModFix/>
          </a:blip>
          <a:srcRect t="69362"/>
          <a:stretch/>
        </p:blipFill>
        <p:spPr>
          <a:xfrm>
            <a:off x="1141301" y="1535183"/>
            <a:ext cx="9126735" cy="95615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E2E54B8-CE6D-4405-AC71-A46054A469DD}"/>
              </a:ext>
            </a:extLst>
          </p:cNvPr>
          <p:cNvSpPr txBox="1"/>
          <p:nvPr/>
        </p:nvSpPr>
        <p:spPr>
          <a:xfrm>
            <a:off x="1141301" y="3283333"/>
            <a:ext cx="1820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r>
              <a:rPr lang="en-US" dirty="0"/>
              <a:t>. AtSUC2:GUS</a:t>
            </a:r>
            <a:endParaRPr lang="LID4096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7A9BF4-2D5C-4C55-8A11-B7D2D8294E1E}"/>
              </a:ext>
            </a:extLst>
          </p:cNvPr>
          <p:cNvSpPr txBox="1"/>
          <p:nvPr/>
        </p:nvSpPr>
        <p:spPr>
          <a:xfrm>
            <a:off x="1141301" y="1144658"/>
            <a:ext cx="2024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r>
              <a:rPr lang="en-US" dirty="0"/>
              <a:t>. RNAi constructs</a:t>
            </a:r>
            <a:endParaRPr lang="LID4096" dirty="0"/>
          </a:p>
        </p:txBody>
      </p:sp>
      <p:pic>
        <p:nvPicPr>
          <p:cNvPr id="7" name="Google Shape;122;p18">
            <a:extLst>
              <a:ext uri="{FF2B5EF4-FFF2-40B4-BE49-F238E27FC236}">
                <a16:creationId xmlns:a16="http://schemas.microsoft.com/office/drawing/2014/main" id="{9E3F8D22-ED15-4866-86C1-D1B422695B57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t="12644" b="59669"/>
          <a:stretch/>
        </p:blipFill>
        <p:spPr>
          <a:xfrm>
            <a:off x="1141301" y="3775048"/>
            <a:ext cx="9126735" cy="86406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53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snat Malka</dc:creator>
  <cp:lastModifiedBy>Shai Morin</cp:lastModifiedBy>
  <cp:revision>9</cp:revision>
  <dcterms:created xsi:type="dcterms:W3CDTF">2026-01-21T11:09:06Z</dcterms:created>
  <dcterms:modified xsi:type="dcterms:W3CDTF">2026-02-16T08:15:02Z</dcterms:modified>
</cp:coreProperties>
</file>